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5" r:id="rId4"/>
    <p:sldId id="266" r:id="rId5"/>
    <p:sldId id="268" r:id="rId6"/>
    <p:sldId id="269" r:id="rId7"/>
    <p:sldId id="270" r:id="rId8"/>
    <p:sldId id="271" r:id="rId9"/>
    <p:sldId id="272" r:id="rId10"/>
    <p:sldId id="273" r:id="rId11"/>
    <p:sldId id="274" r:id="rId12"/>
    <p:sldId id="275" r:id="rId13"/>
    <p:sldId id="276" r:id="rId14"/>
    <p:sldId id="277" r:id="rId15"/>
    <p:sldId id="278" r:id="rId16"/>
    <p:sldId id="264" r:id="rId17"/>
    <p:sldId id="267" r:id="rId18"/>
    <p:sldId id="280" r:id="rId1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1800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1552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171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527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5238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2289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911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1707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5324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702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488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43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1CCB7-9A46-452C-AB07-CD4B47D8B890}" type="datetimeFigureOut">
              <a:rPr lang="en-GB" smtClean="0"/>
              <a:t>18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28B23-66DF-4BB8-9DDA-E23604C048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58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D64524-A14F-C7DE-D86B-0DCB2F4198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9658631-6C7F-D10F-CA71-37D9038438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2462" y="1393594"/>
            <a:ext cx="6519863" cy="260508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29FD833-165A-9E98-F8D4-0FFFCE813A42}"/>
              </a:ext>
            </a:extLst>
          </p:cNvPr>
          <p:cNvSpPr txBox="1"/>
          <p:nvPr/>
        </p:nvSpPr>
        <p:spPr>
          <a:xfrm>
            <a:off x="932836" y="110255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15501C6-BB1D-B6F6-0588-82EE394AC23F}"/>
              </a:ext>
            </a:extLst>
          </p:cNvPr>
          <p:cNvSpPr txBox="1"/>
          <p:nvPr/>
        </p:nvSpPr>
        <p:spPr>
          <a:xfrm>
            <a:off x="4767979" y="107605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4FA3FF-7F32-E2E9-9487-C9E8B82F25EF}"/>
              </a:ext>
            </a:extLst>
          </p:cNvPr>
          <p:cNvSpPr txBox="1"/>
          <p:nvPr/>
        </p:nvSpPr>
        <p:spPr>
          <a:xfrm>
            <a:off x="361744" y="4161862"/>
            <a:ext cx="8521000" cy="1838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1. Correlation between changes in transcription and protein abundance.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Linear regression between the changes in abundance of all 856 proteins for which corresponding transcriptome data is also available for each comparison between pairs of developmental stages. The x-axis shows the fold changes (log2 scale) detected in the proteomics data and the y-axis the changes in gene-level transcription. Significant R2 values are shown (p&lt;=0.001).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Pearson's product-moment correlations for the data for the comparisons shown in panel A. The y-axis corresponds to  –log10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such that more significant results are displayed at higher values, and the x-axis indicates the developmental stage comparison. The horizontal lines mark a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=5e-02 threshold, and the size of each point shown is proportional to the correlation r value.</a:t>
            </a:r>
          </a:p>
        </p:txBody>
      </p:sp>
    </p:spTree>
    <p:extLst>
      <p:ext uri="{BB962C8B-B14F-4D97-AF65-F5344CB8AC3E}">
        <p14:creationId xmlns:p14="http://schemas.microsoft.com/office/powerpoint/2010/main" val="16437011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B334C6-EBE7-6BDD-8F43-DE90B60242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D226E70-5C17-F54D-3D1A-E42AB21E7B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338DBC9-8844-3563-3C02-5EC6EC8FAA7B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41776624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DBA907-FDC1-0482-FA3F-1E62CFC6CE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360D80-412C-25A5-51D6-F190635698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35D862E-9D95-248A-EA66-6574E9F05BC1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27034791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40C9DA-7F69-3CE9-2567-FAB4D77116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BE92939-36FA-09E8-FE01-C717ADD1E3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E572746-4434-47A1-0736-5088AEE6F88B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8010815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2034FD-AC9A-8AF1-4752-9EBEB7FB22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B49E4A-7B14-3B18-F815-CC4B2545DD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408FDD6-A654-3959-B6E6-39A7E7E27DF7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231247091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7FF4CC-DCEB-A79B-F7CF-7C24B93A83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AFD8454-E4DE-1BD7-7526-CCFB54055A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97C52B-2E2A-4502-BA79-5CAF1F41391F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7185067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6C2C1F7-DAE5-278D-0D35-DF99B9E02E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C5E37D7-2B4D-3D19-F0E3-8042E0F4C7EC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1612055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4757D03-1F66-FD84-FE4F-B1D3715617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466B9E7-6E21-63CE-6559-9F15F45F233E}"/>
              </a:ext>
            </a:extLst>
          </p:cNvPr>
          <p:cNvSpPr txBox="1"/>
          <p:nvPr/>
        </p:nvSpPr>
        <p:spPr>
          <a:xfrm>
            <a:off x="502418" y="522514"/>
            <a:ext cx="55643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83149323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50C5B53-FFAC-B810-07FC-8A330AD173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A9E083-F975-5FC2-36E9-F282EBF4D602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155230364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A62EA14-D4A3-1422-4BF4-FBC316543238}"/>
              </a:ext>
            </a:extLst>
          </p:cNvPr>
          <p:cNvSpPr txBox="1"/>
          <p:nvPr/>
        </p:nvSpPr>
        <p:spPr>
          <a:xfrm>
            <a:off x="195913" y="202630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CB7D6F3-E1D8-8583-9581-D01B50C1B081}"/>
              </a:ext>
            </a:extLst>
          </p:cNvPr>
          <p:cNvSpPr txBox="1"/>
          <p:nvPr/>
        </p:nvSpPr>
        <p:spPr>
          <a:xfrm>
            <a:off x="195913" y="36393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BC78BFC-EECB-7878-9E36-0335C1E25F6E}"/>
              </a:ext>
            </a:extLst>
          </p:cNvPr>
          <p:cNvGrpSpPr>
            <a:grpSpLocks noChangeAspect="1"/>
          </p:cNvGrpSpPr>
          <p:nvPr/>
        </p:nvGrpSpPr>
        <p:grpSpPr>
          <a:xfrm>
            <a:off x="544563" y="571727"/>
            <a:ext cx="1627200" cy="1627200"/>
            <a:chOff x="2318908" y="1659415"/>
            <a:chExt cx="1366667" cy="1366667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AB03528-38C4-59B2-0F40-C5D3A0A8D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18908" y="1659415"/>
              <a:ext cx="1366667" cy="1366667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2238DB6-0ED4-CB6D-492D-EF1A14D42D99}"/>
                </a:ext>
              </a:extLst>
            </p:cNvPr>
            <p:cNvSpPr/>
            <p:nvPr/>
          </p:nvSpPr>
          <p:spPr>
            <a:xfrm>
              <a:off x="2319076" y="201930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E99FC2A-37C4-8F5C-8481-143BA784B276}"/>
              </a:ext>
            </a:extLst>
          </p:cNvPr>
          <p:cNvGrpSpPr>
            <a:grpSpLocks noChangeAspect="1"/>
          </p:cNvGrpSpPr>
          <p:nvPr/>
        </p:nvGrpSpPr>
        <p:grpSpPr>
          <a:xfrm>
            <a:off x="2508365" y="571727"/>
            <a:ext cx="1663778" cy="1627200"/>
            <a:chOff x="3739714" y="1659414"/>
            <a:chExt cx="1397563" cy="1366838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315FE182-3BCA-6615-A340-ED6B17E1A7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70439" y="1659414"/>
              <a:ext cx="1366838" cy="1366838"/>
            </a:xfrm>
            <a:prstGeom prst="rect">
              <a:avLst/>
            </a:prstGeom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44D3B2F1-3516-9904-FD2A-0B4ED89CE9AE}"/>
                </a:ext>
              </a:extLst>
            </p:cNvPr>
            <p:cNvSpPr/>
            <p:nvPr/>
          </p:nvSpPr>
          <p:spPr>
            <a:xfrm>
              <a:off x="3739714" y="201930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FF06B4D6-0730-FD8B-4D54-983C9DC9F9EC}"/>
              </a:ext>
            </a:extLst>
          </p:cNvPr>
          <p:cNvGrpSpPr>
            <a:grpSpLocks noChangeAspect="1"/>
          </p:cNvGrpSpPr>
          <p:nvPr/>
        </p:nvGrpSpPr>
        <p:grpSpPr>
          <a:xfrm>
            <a:off x="2544842" y="2219795"/>
            <a:ext cx="1627301" cy="1627200"/>
            <a:chOff x="3770439" y="3191697"/>
            <a:chExt cx="1366923" cy="1366838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C1A7AB7B-0221-8A85-02A8-5D34464DF4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70524" y="3191697"/>
              <a:ext cx="1366838" cy="1366838"/>
            </a:xfrm>
            <a:prstGeom prst="rect">
              <a:avLst/>
            </a:prstGeom>
          </p:spPr>
        </p:pic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24CA3474-B4E2-A1FF-C0DB-D511086A2FD4}"/>
                </a:ext>
              </a:extLst>
            </p:cNvPr>
            <p:cNvSpPr/>
            <p:nvPr/>
          </p:nvSpPr>
          <p:spPr>
            <a:xfrm>
              <a:off x="3770439" y="354711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96C7E4B6-5BC1-988C-40F1-BC72D3F0B1E5}"/>
              </a:ext>
            </a:extLst>
          </p:cNvPr>
          <p:cNvGrpSpPr>
            <a:grpSpLocks noChangeAspect="1"/>
          </p:cNvGrpSpPr>
          <p:nvPr/>
        </p:nvGrpSpPr>
        <p:grpSpPr>
          <a:xfrm>
            <a:off x="544563" y="2219795"/>
            <a:ext cx="1627200" cy="1627200"/>
            <a:chOff x="2318907" y="3191697"/>
            <a:chExt cx="1366838" cy="1366838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74338BC7-4882-CA69-140F-AF37F0D00D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18907" y="3191697"/>
              <a:ext cx="1366838" cy="1366838"/>
            </a:xfrm>
            <a:prstGeom prst="rect">
              <a:avLst/>
            </a:prstGeom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E7C22FF-FF2F-FF15-2AC7-FCDB98C54917}"/>
                </a:ext>
              </a:extLst>
            </p:cNvPr>
            <p:cNvSpPr/>
            <p:nvPr/>
          </p:nvSpPr>
          <p:spPr>
            <a:xfrm>
              <a:off x="2318907" y="356675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21C3FBB5-93AE-B927-BC60-57759DED8CDF}"/>
              </a:ext>
            </a:extLst>
          </p:cNvPr>
          <p:cNvGrpSpPr>
            <a:grpSpLocks noChangeAspect="1"/>
          </p:cNvGrpSpPr>
          <p:nvPr/>
        </p:nvGrpSpPr>
        <p:grpSpPr>
          <a:xfrm>
            <a:off x="4508744" y="2218220"/>
            <a:ext cx="1628775" cy="1628775"/>
            <a:chOff x="5222141" y="3191697"/>
            <a:chExt cx="1366838" cy="1366838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86FDCE08-7370-6005-A1A6-4E36CF36401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222141" y="3191697"/>
              <a:ext cx="1366838" cy="1366838"/>
            </a:xfrm>
            <a:prstGeom prst="rect">
              <a:avLst/>
            </a:prstGeom>
          </p:spPr>
        </p:pic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A8994F0-F205-D8BE-F259-C4D7327DEBC2}"/>
                </a:ext>
              </a:extLst>
            </p:cNvPr>
            <p:cNvSpPr/>
            <p:nvPr/>
          </p:nvSpPr>
          <p:spPr>
            <a:xfrm>
              <a:off x="5222141" y="356675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378AA69A-F90B-7A37-7F9E-D7BD989265B1}"/>
              </a:ext>
            </a:extLst>
          </p:cNvPr>
          <p:cNvGrpSpPr>
            <a:grpSpLocks noChangeAspect="1"/>
          </p:cNvGrpSpPr>
          <p:nvPr/>
        </p:nvGrpSpPr>
        <p:grpSpPr>
          <a:xfrm>
            <a:off x="4508744" y="570152"/>
            <a:ext cx="1665592" cy="1628775"/>
            <a:chOff x="5191243" y="1659414"/>
            <a:chExt cx="1397736" cy="1366838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26A0C540-FE18-7C2B-29AF-3067D7AB4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22141" y="1659414"/>
              <a:ext cx="1366838" cy="1366838"/>
            </a:xfrm>
            <a:prstGeom prst="rect">
              <a:avLst/>
            </a:prstGeom>
          </p:spPr>
        </p:pic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A4C0EF5-D1E8-1EDA-2052-D5B4FC048B83}"/>
                </a:ext>
              </a:extLst>
            </p:cNvPr>
            <p:cNvSpPr/>
            <p:nvPr/>
          </p:nvSpPr>
          <p:spPr>
            <a:xfrm>
              <a:off x="5191243" y="2019300"/>
              <a:ext cx="134733" cy="2057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F098BA9F-665D-57B2-E32E-FB40FB3753A2}"/>
              </a:ext>
            </a:extLst>
          </p:cNvPr>
          <p:cNvSpPr txBox="1"/>
          <p:nvPr/>
        </p:nvSpPr>
        <p:spPr>
          <a:xfrm>
            <a:off x="169425" y="4147844"/>
            <a:ext cx="8783656" cy="2092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3. Comparison of the abundances of 6 putativ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hosphopep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from Table 2 for each developmental stage (x-axis) relative to the total abundance values for each protein. Only data for proteins with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hosphopep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detected in more than one sample are shown. All abundances shown are based on raw values but are displayed on a y-axis organised in the log2 scale. Error bars are included for when replicate values are available (n=2 or 3). The absence of error bars indicates a situation where data are available for only one of the three replicates in a particular stage. See Supplementary Data S5 for assignments and abundance values, and Supplementary Fig. S2 for MS/MS spectra. Panel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esents proteins related to muscle function (XP_023950391, myosin regulatory light chain 2; XP_052741313, myosin heavy chain; XP_052738629, PDZ and LIM domain protein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Zas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, and panel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he other proteins identified (XP_052741399, larval cuticle protein; XP_023943025, rho guanine nucleotide exchange factor 7; XP_023948915, pre-mRNA-processing-splicing factor 8).</a:t>
            </a:r>
          </a:p>
        </p:txBody>
      </p:sp>
    </p:spTree>
    <p:extLst>
      <p:ext uri="{BB962C8B-B14F-4D97-AF65-F5344CB8AC3E}">
        <p14:creationId xmlns:p14="http://schemas.microsoft.com/office/powerpoint/2010/main" val="42432693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42D9CEB-2DCB-31BB-714D-2784FD6958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43139"/>
            <a:ext cx="9144000" cy="49717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A11D81F-10D8-7377-9E85-B95B2B7C0802}"/>
              </a:ext>
            </a:extLst>
          </p:cNvPr>
          <p:cNvSpPr txBox="1"/>
          <p:nvPr/>
        </p:nvSpPr>
        <p:spPr>
          <a:xfrm>
            <a:off x="502418" y="512466"/>
            <a:ext cx="4905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. MS/MS spectra of the phosphorylated peptides listed in Table 2. </a:t>
            </a:r>
          </a:p>
        </p:txBody>
      </p:sp>
    </p:spTree>
    <p:extLst>
      <p:ext uri="{BB962C8B-B14F-4D97-AF65-F5344CB8AC3E}">
        <p14:creationId xmlns:p14="http://schemas.microsoft.com/office/powerpoint/2010/main" val="26625513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13E345B-C3E0-4C80-829D-F0626B1DD1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58539"/>
            <a:ext cx="9144000" cy="514092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6CEFB3C-6DD0-3358-C341-A5B52462173C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22163987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183C523-BE3C-4756-03EC-29831FC8AA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6B9AD88-A2D5-B256-3EDD-4DBDE6774C64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1810795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C578F0-41FD-5210-704C-8B869125CB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C729BE-1038-4A55-FA14-F5910CC635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3E1744D-3176-B52E-F7F9-E0FC78CEC3AD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7982455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26CD6F-F86C-51EA-5B2D-8E29A84D8E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518FE4D-0F25-6A65-0F75-CB5EF85E37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9884B81-07E2-90C2-7EF8-94D1A9EFBA13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23042552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CC3DD3-51EE-AD15-95BB-C53D384B69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F0D3165-2B6E-BFF4-FFEE-BDA7282C20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FBC7DDF-0B7D-F307-A88C-FBB380079370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40589969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90B198-86D8-DE23-6493-0EB7006095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7FE3406-3681-3982-D306-097D2A9124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763FAC4-E7F3-8CA9-E4FE-F6CE9969BEBF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8084176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9AF60D-65AB-906E-9D29-5E30A67AF7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7ECC0D3-4EA6-960E-3638-71F920B13D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0241"/>
            <a:ext cx="9144000" cy="5097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ED88249-5E4D-6B39-3ED3-6A44986EA6F0}"/>
              </a:ext>
            </a:extLst>
          </p:cNvPr>
          <p:cNvSpPr txBox="1"/>
          <p:nvPr/>
        </p:nvSpPr>
        <p:spPr>
          <a:xfrm>
            <a:off x="502418" y="522514"/>
            <a:ext cx="5610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igure S2 (continued). MS/MS spectra of the phosphorylated peptides listed in Table 2.</a:t>
            </a:r>
          </a:p>
        </p:txBody>
      </p:sp>
    </p:spTree>
    <p:extLst>
      <p:ext uri="{BB962C8B-B14F-4D97-AF65-F5344CB8AC3E}">
        <p14:creationId xmlns:p14="http://schemas.microsoft.com/office/powerpoint/2010/main" val="3259960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3</TotalTime>
  <Words>639</Words>
  <Application>Microsoft Office PowerPoint</Application>
  <PresentationFormat>On-screen Show (4:3)</PresentationFormat>
  <Paragraphs>22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gh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Hesketh</dc:creator>
  <cp:lastModifiedBy>MDPI</cp:lastModifiedBy>
  <cp:revision>35</cp:revision>
  <dcterms:created xsi:type="dcterms:W3CDTF">2024-11-27T12:49:10Z</dcterms:created>
  <dcterms:modified xsi:type="dcterms:W3CDTF">2025-12-18T15:14:24Z</dcterms:modified>
</cp:coreProperties>
</file>